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4AE7FF-F36E-40E0-968A-ED6551F8BFA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0B9FBA-A6D0-4752-A5B8-990261F5AA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2EF2F9-95AA-438C-846C-E0081C2E94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75468-688C-4293-B4FE-0EEFBF9599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F8CBF42-1472-44CB-BA40-E5041EC137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15502A7-1598-4B04-9223-7EE0951325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696559A-B04B-486B-86DB-CFA993DD25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8559C0F-8D50-46C3-A68D-207FD22B8F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D24B23A-0A62-40B4-97BA-83BB3D1411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B6724CF-F735-4CFA-BFC7-0C990BE156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5EE3B52-D251-4768-B568-262E0DAA94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BE475-34B9-4353-AEF7-C5CD8F03AB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FB7030D-CE67-4BA5-A5D3-754BC6AE82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85C6335-9973-4946-B6A5-F91DB078AB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BF8CCEE-DCFE-4B6D-B7D3-574328F9A1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A4B63CD-9B3F-4D40-B66E-683BB4E8DF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8A3F479-3458-4FBE-A89D-4FF85EEC09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4C4906-EF64-4425-81E3-6E73F3FFAD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602E4-D5E7-47EE-B09B-C5DC0603AC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97764-8767-4360-90AD-D1416E745D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2AF2D5-AA34-4ABF-AFDB-D4BF2BDA76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E8FB67-51DE-4293-8572-5FB3F17111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E19F6-4E69-4B12-B026-B64AF0D31A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4D8AA8-800E-4311-A603-FCF5D77D3D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1347F5-4BDB-4534-B1C3-9AC5B34B8026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18BAD3-6CA8-41D1-AF9D-998E4F61BCB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735120" y="620640"/>
            <a:ext cx="7292880" cy="1008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 Figure 1, </a:t>
            </a:r>
            <a:br>
              <a:rPr sz="1800"/>
            </a:b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Pretreatment with GBE has no significant effects on  chronic high-glucose- induced AP-1 and NF-</a:t>
            </a:r>
            <a:r>
              <a:rPr b="1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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 activation in HEACs.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3" name="Group 31"/>
          <p:cNvGrpSpPr/>
          <p:nvPr/>
        </p:nvGrpSpPr>
        <p:grpSpPr>
          <a:xfrm>
            <a:off x="971640" y="2133720"/>
            <a:ext cx="7776000" cy="3165120"/>
            <a:chOff x="971640" y="2133720"/>
            <a:chExt cx="7776000" cy="3165120"/>
          </a:xfrm>
        </p:grpSpPr>
        <p:grpSp>
          <p:nvGrpSpPr>
            <p:cNvPr id="84" name="Group 25"/>
            <p:cNvGrpSpPr/>
            <p:nvPr/>
          </p:nvGrpSpPr>
          <p:grpSpPr>
            <a:xfrm>
              <a:off x="971640" y="2133720"/>
              <a:ext cx="7776000" cy="3165120"/>
              <a:chOff x="971640" y="2133720"/>
              <a:chExt cx="7776000" cy="3165120"/>
            </a:xfrm>
          </p:grpSpPr>
          <p:grpSp>
            <p:nvGrpSpPr>
              <p:cNvPr id="85" name="Group 21"/>
              <p:cNvGrpSpPr/>
              <p:nvPr/>
            </p:nvGrpSpPr>
            <p:grpSpPr>
              <a:xfrm>
                <a:off x="971640" y="2133720"/>
                <a:ext cx="3976560" cy="3124440"/>
                <a:chOff x="971640" y="2133720"/>
                <a:chExt cx="3976560" cy="3124440"/>
              </a:xfrm>
            </p:grpSpPr>
            <p:pic>
              <p:nvPicPr>
                <p:cNvPr id="86" name="Picture 4" descr="新資料夾"/>
                <p:cNvPicPr/>
                <p:nvPr/>
              </p:nvPicPr>
              <p:blipFill>
                <a:blip r:embed="rId1">
                  <a:lum bright="6000"/>
                </a:blip>
                <a:srcRect l="6915" t="28727" r="15490" b="21591"/>
                <a:stretch/>
              </p:blipFill>
              <p:spPr>
                <a:xfrm>
                  <a:off x="2276640" y="3519000"/>
                  <a:ext cx="2078280" cy="17391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87" name="Text Box 16"/>
                <p:cNvSpPr/>
                <p:nvPr/>
              </p:nvSpPr>
              <p:spPr>
                <a:xfrm>
                  <a:off x="971640" y="2133720"/>
                  <a:ext cx="3976560" cy="1140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</a:rPr>
                    <a:t> 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Glucose (25 mM)             -      +       -      +       -      +      -     +       -                 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 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Mannitol (25 mM)           -       -      +       -       +      -     +      -      +    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 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GBE  (100 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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g/ml)              -      -       -      +      +      -      -      -       -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 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NAC (1  m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M)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                     -      -       -       -       -      +    +      -       -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 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Staurosporine (100 nM)   -      -       -       -       -      -      -      +      +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8" name="Group 22"/>
              <p:cNvGrpSpPr/>
              <p:nvPr/>
            </p:nvGrpSpPr>
            <p:grpSpPr>
              <a:xfrm>
                <a:off x="4603680" y="2244960"/>
                <a:ext cx="4143960" cy="3053880"/>
                <a:chOff x="4603680" y="2244960"/>
                <a:chExt cx="4143960" cy="3053880"/>
              </a:xfrm>
            </p:grpSpPr>
            <p:grpSp>
              <p:nvGrpSpPr>
                <p:cNvPr id="89" name="Group 7"/>
                <p:cNvGrpSpPr/>
                <p:nvPr/>
              </p:nvGrpSpPr>
              <p:grpSpPr>
                <a:xfrm>
                  <a:off x="5862960" y="3519000"/>
                  <a:ext cx="2077920" cy="1779840"/>
                  <a:chOff x="5862960" y="3519000"/>
                  <a:chExt cx="2077920" cy="1779840"/>
                </a:xfrm>
              </p:grpSpPr>
              <p:pic>
                <p:nvPicPr>
                  <p:cNvPr id="90" name="Picture 8" descr="新資料夾009"/>
                  <p:cNvPicPr/>
                  <p:nvPr/>
                </p:nvPicPr>
                <p:blipFill>
                  <a:blip r:embed="rId2"/>
                  <a:srcRect l="9527" t="0" r="12696" b="0"/>
                  <a:stretch/>
                </p:blipFill>
                <p:spPr>
                  <a:xfrm>
                    <a:off x="5862960" y="3519000"/>
                    <a:ext cx="2070000" cy="543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91" name="Picture 9" descr="新資料夾003"/>
                  <p:cNvPicPr/>
                  <p:nvPr/>
                </p:nvPicPr>
                <p:blipFill>
                  <a:blip r:embed="rId3">
                    <a:lum contrast="-54000"/>
                  </a:blip>
                  <a:srcRect l="0" t="25634" r="0" b="0"/>
                  <a:stretch/>
                </p:blipFill>
                <p:spPr>
                  <a:xfrm>
                    <a:off x="5870880" y="4038120"/>
                    <a:ext cx="2070000" cy="1260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sp>
              <p:nvSpPr>
                <p:cNvPr id="92" name="Text Box 17"/>
                <p:cNvSpPr/>
                <p:nvPr/>
              </p:nvSpPr>
              <p:spPr>
                <a:xfrm>
                  <a:off x="4603680" y="2244960"/>
                  <a:ext cx="4143960" cy="1064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Glucose (25 mM)              -      +       -       +     -       +       -       +       -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Mannitol (25 mM)            -       -      +       -     +       -       +        -      +    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GBE (100 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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g/ml)               -      -       -       +     +       -       -        -       -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NAC (1 m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M)</a:t>
                  </a: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                     -       -      -        -      -       +      +       -        -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spcBef>
                      <a:spcPts val="56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Times New Roman"/>
                    </a:rPr>
                    <a:t>Staurosporine (10 nM)     -       -      -      -       -       -       -       +       +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93" name="Text Box 26"/>
            <p:cNvSpPr/>
            <p:nvPr/>
          </p:nvSpPr>
          <p:spPr>
            <a:xfrm>
              <a:off x="1694520" y="3816360"/>
              <a:ext cx="42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P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27"/>
            <p:cNvSpPr/>
            <p:nvPr/>
          </p:nvSpPr>
          <p:spPr>
            <a:xfrm>
              <a:off x="5181480" y="3776760"/>
              <a:ext cx="527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NF- </a:t>
              </a:r>
              <a:r>
                <a:rPr b="0" lang="en-US" sz="1000" spc="-1" strike="noStrike">
                  <a:solidFill>
                    <a:srgbClr val="1f497d"/>
                  </a:solidFill>
                  <a:latin typeface="Symbol"/>
                  <a:ea typeface="Symbol"/>
                </a:rPr>
                <a:t></a:t>
              </a:r>
              <a:r>
                <a:rPr b="0" lang="en-US" sz="1000" spc="-1" strike="noStrike">
                  <a:solidFill>
                    <a:srgbClr val="1f497d"/>
                  </a:solidFill>
                  <a:latin typeface="Calibri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5" name="矩形 23"/>
          <p:cNvSpPr/>
          <p:nvPr/>
        </p:nvSpPr>
        <p:spPr>
          <a:xfrm>
            <a:off x="820080" y="5661000"/>
            <a:ext cx="208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taurosporine, a PKC inhibito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 Figure 2, </a:t>
            </a:r>
            <a:br>
              <a:rPr sz="1800"/>
            </a:b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Pretreatment with GBE does-dependently suppressed high glucose-induced ICAM-1 accumulation in HAECs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7" name="圖片 5" descr=""/>
          <p:cNvPicPr/>
          <p:nvPr/>
        </p:nvPicPr>
        <p:blipFill>
          <a:blip r:embed="rId1"/>
          <a:srcRect l="23878" t="15496" r="26205" b="56808"/>
          <a:stretch/>
        </p:blipFill>
        <p:spPr>
          <a:xfrm>
            <a:off x="1187280" y="2276640"/>
            <a:ext cx="6048720" cy="2736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457200" y="4759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 Figure 3, </a:t>
            </a:r>
            <a:br>
              <a:rPr sz="1800"/>
            </a:b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Endothelial ICAM-1 expression was increased by high-glucose (25mM) stimulation for 4 days, which was losing after the replacement of normal glucose medium (5mM) for 1-4 days.</a:t>
            </a: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9" name="圖片 3" descr=""/>
          <p:cNvPicPr/>
          <p:nvPr/>
        </p:nvPicPr>
        <p:blipFill>
          <a:blip r:embed="rId1"/>
          <a:srcRect l="17850" t="20525" r="19795" b="46362"/>
          <a:stretch/>
        </p:blipFill>
        <p:spPr>
          <a:xfrm>
            <a:off x="1403280" y="1628640"/>
            <a:ext cx="6193080" cy="2671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16T06:31:31Z</dcterms:created>
  <dc:creator>User</dc:creator>
  <dc:description/>
  <dc:language>en-US</dc:language>
  <cp:lastModifiedBy>User</cp:lastModifiedBy>
  <dcterms:modified xsi:type="dcterms:W3CDTF">2012-04-23T09:55:52Z</dcterms:modified>
  <cp:revision>17</cp:revision>
  <dc:subject/>
  <dc:title>Supplement Figure 1, High-glucose up-regulates ICAM-1 &amp; IL-6 expression in human aortic endothelial cells (n=4) (* p&lt;0.05 vs. 0 day)</dc:title>
</cp:coreProperties>
</file>